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76634C-3C46-410F-BCC4-784E160FB1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B8BBF89-AE74-431D-971D-AE2829B405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DDF682-462B-4E28-933F-40EC0C4C4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DE7392-EA17-4E5B-A5FB-047F75B38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6FD61D-9625-47BF-A480-0B3335EBB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217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861F56-A5A9-4511-8470-847F829C7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9F3A2F3-7069-469D-AF0F-C4EEBF4804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6016F3-A428-49DB-91A1-3662D84EB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B01DE0-24C5-4C8C-A19E-08221732F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AC20B0-AD14-4BDD-9660-B69A04239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375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50E46E2-CADE-4683-A900-A2A4CCD10E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42FE1C-B1DD-413C-8395-334B2095B2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CA5099-20A1-426E-A5B4-1A16CCC8C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6378B4-F5BE-4870-8C5C-C852DB767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32408E-664D-46BE-A3FC-C733E9918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811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C7EFF7-A112-4633-B615-8E01E49E5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94AF52-D13D-4D7B-8571-B4C5081B8F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DD5C4A-5CC9-453D-A049-18FDFC47C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1FF1BA-0E28-4A05-8668-F8735F72F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1455AF-C9BA-47B9-86E8-9EE532EB0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792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5B25E9-EE75-4F73-BBF3-BC2029C06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95ACBF-FC1D-42CD-BF89-EC94DBC7EE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17828A-9757-4E9F-8563-016AEB059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98E85E-31CB-41A3-8658-BBEFD0A30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C3B59C7-1F77-4551-B5E5-4E28D25DC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321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169FCC-0F0F-4BD6-ACC0-27D77CB2E5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8ECEACA-62E1-4CD3-B7BA-3EE503BB6E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E328679-1586-493A-9F4C-B1CA3BA019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A13003-BC43-4D12-B3C1-AF0D1E616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97AB07-A3F3-4158-9C11-67CF9197E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621EF4C-6DDD-4264-999E-61C9132AE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909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BD675C-3BEC-4394-9A4D-1639BD731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A7C34F8-E822-431B-AFFC-BD732717E6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8FB8315-E98C-469C-AF99-3BBAA96B49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2978F03-B4CE-479F-A05A-8B56241FA3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170249A-7AF5-4747-A622-F0E713148E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C469995-5D4D-4F43-B67F-301A3276E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AA49F5C-F9C5-4DBB-9727-332DD747A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7EF93C2-5798-4A6B-A2AB-BFC6813E8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952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773DC5-FFA8-43FC-B49E-077885AE6C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AD67340-2E51-4202-82E2-64367369A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AD46A01-229F-467A-8311-E833C0B0B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C66342A-7576-4F05-8919-CADED3177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71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85CF7EF-6285-4845-8EFC-B7E1A5513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33F4D39-C98C-4708-A55E-4354617BD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8CB3F2C-3270-4319-84B5-F1803F062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28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A4354E-A226-4BA8-A56E-613D390E46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D284062-8AA7-4358-BA71-6FBF6216C7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8CDF5FC-5CF9-4C90-B9CF-8427DAA37F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24E776C-231D-4F75-A1D5-7B2DFC478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8D7CD5-9905-441A-A5E5-007943482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E244D5-35C2-4DDC-9A1E-121AFAAAB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497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F71CDC-65EA-43E7-AF0F-03A5F7276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3748F88-4C32-44EC-82EC-CBA77CBC9B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B14F441-82D7-400F-A477-C44A0910C3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AC3D0CE-BC7A-4309-B4E8-46E6B83E8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43910A-BC5F-48E5-97D3-976F6FF15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E8BF7D4-165F-4F9E-A24F-0783B3E45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431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A76F60E-4310-4E10-9523-9544F10EB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887722B-0479-48C6-AECF-1E473D1ADA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A56E8A-E4A8-4121-9AB3-05DDAAD9AD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07F730-E322-46F6-8E87-3ADC80787A73}" type="datetimeFigureOut">
              <a:rPr lang="en-US" smtClean="0"/>
              <a:t>1/22/2025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764E84-B404-440E-A01E-D300FE11BE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44D099-1368-469D-B4EB-E651C50DB5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9B595-63CA-4EDC-997F-DD6A2A181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47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782D8CEA-E93B-4DB5-A0ED-54695E0030CB}"/>
              </a:ext>
            </a:extLst>
          </p:cNvPr>
          <p:cNvGrpSpPr/>
          <p:nvPr/>
        </p:nvGrpSpPr>
        <p:grpSpPr>
          <a:xfrm>
            <a:off x="4698373" y="1177610"/>
            <a:ext cx="2520000" cy="2520000"/>
            <a:chOff x="9556188" y="1206889"/>
            <a:chExt cx="2520000" cy="2520000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0FC84F21-A8AC-44A1-B429-85C3F25F9B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56188" y="1206889"/>
              <a:ext cx="2520000" cy="2520000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B3D3B799-D2D8-4926-8B89-ABE5121CC9DC}"/>
                </a:ext>
              </a:extLst>
            </p:cNvPr>
            <p:cNvSpPr txBox="1"/>
            <p:nvPr/>
          </p:nvSpPr>
          <p:spPr>
            <a:xfrm>
              <a:off x="10281426" y="2336084"/>
              <a:ext cx="11480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hromosome 6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58B0C85-05C4-47BC-8EEC-61EDAC550E86}"/>
                </a:ext>
              </a:extLst>
            </p:cNvPr>
            <p:cNvSpPr txBox="1"/>
            <p:nvPr/>
          </p:nvSpPr>
          <p:spPr>
            <a:xfrm>
              <a:off x="9556188" y="1514056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F94BCDF6-47D5-4F1B-85BA-0B8200959C6C}"/>
              </a:ext>
            </a:extLst>
          </p:cNvPr>
          <p:cNvGrpSpPr/>
          <p:nvPr/>
        </p:nvGrpSpPr>
        <p:grpSpPr>
          <a:xfrm>
            <a:off x="8136720" y="1149701"/>
            <a:ext cx="2520000" cy="2520000"/>
            <a:chOff x="628599" y="3920498"/>
            <a:chExt cx="2520000" cy="2520000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60E1E699-2498-4A95-8E10-925335ADCB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599" y="3920498"/>
              <a:ext cx="2520000" cy="2520000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917E0544-1285-4523-871F-15EF9D512BED}"/>
                </a:ext>
              </a:extLst>
            </p:cNvPr>
            <p:cNvSpPr txBox="1"/>
            <p:nvPr/>
          </p:nvSpPr>
          <p:spPr>
            <a:xfrm>
              <a:off x="1311904" y="5049693"/>
              <a:ext cx="11480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hromosome 7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DB411D9-DCF7-4B62-8B7E-ACE60B25F712}"/>
                </a:ext>
              </a:extLst>
            </p:cNvPr>
            <p:cNvSpPr txBox="1"/>
            <p:nvPr/>
          </p:nvSpPr>
          <p:spPr>
            <a:xfrm>
              <a:off x="628599" y="4186110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8C941096-54E4-45D0-AF60-27F0566A54A0}"/>
              </a:ext>
            </a:extLst>
          </p:cNvPr>
          <p:cNvGrpSpPr/>
          <p:nvPr/>
        </p:nvGrpSpPr>
        <p:grpSpPr>
          <a:xfrm>
            <a:off x="967169" y="3861625"/>
            <a:ext cx="2557401" cy="2520000"/>
            <a:chOff x="3471198" y="3920498"/>
            <a:chExt cx="2557401" cy="2520000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FB0F10A3-4A42-4291-B6A1-F3B4396B798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8599" y="3920498"/>
              <a:ext cx="2520000" cy="2520000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8D59EFF-A515-459C-BD1E-E7FF94D800DA}"/>
                </a:ext>
              </a:extLst>
            </p:cNvPr>
            <p:cNvSpPr txBox="1"/>
            <p:nvPr/>
          </p:nvSpPr>
          <p:spPr>
            <a:xfrm>
              <a:off x="4155290" y="5049693"/>
              <a:ext cx="1226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hromosome 10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11D141D-5CD6-4BCF-B252-5DA6DBC07C4B}"/>
                </a:ext>
              </a:extLst>
            </p:cNvPr>
            <p:cNvSpPr txBox="1"/>
            <p:nvPr/>
          </p:nvSpPr>
          <p:spPr>
            <a:xfrm>
              <a:off x="3471198" y="4120080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915C7138-3B92-40AC-BC2A-736761224BAF}"/>
              </a:ext>
            </a:extLst>
          </p:cNvPr>
          <p:cNvGrpSpPr/>
          <p:nvPr/>
        </p:nvGrpSpPr>
        <p:grpSpPr>
          <a:xfrm>
            <a:off x="4698373" y="3825828"/>
            <a:ext cx="2520000" cy="2520000"/>
            <a:chOff x="6463102" y="3992430"/>
            <a:chExt cx="2520000" cy="2520000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5D14CEEB-496F-4676-8CCD-806824E06AB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63102" y="3992430"/>
              <a:ext cx="2520000" cy="2520000"/>
            </a:xfrm>
            <a:prstGeom prst="rect">
              <a:avLst/>
            </a:prstGeom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80A66442-5B36-4259-8BE5-D8C21B499BE8}"/>
                </a:ext>
              </a:extLst>
            </p:cNvPr>
            <p:cNvSpPr txBox="1"/>
            <p:nvPr/>
          </p:nvSpPr>
          <p:spPr>
            <a:xfrm>
              <a:off x="7109793" y="5121625"/>
              <a:ext cx="1226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hromosome 11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02D7EAD8-AB65-4961-9CC3-B95A52033EA4}"/>
                </a:ext>
              </a:extLst>
            </p:cNvPr>
            <p:cNvSpPr txBox="1"/>
            <p:nvPr/>
          </p:nvSpPr>
          <p:spPr>
            <a:xfrm>
              <a:off x="6463102" y="4186110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99E9840F-AD6D-41AE-9778-0C797CE245D1}"/>
              </a:ext>
            </a:extLst>
          </p:cNvPr>
          <p:cNvGrpSpPr/>
          <p:nvPr/>
        </p:nvGrpSpPr>
        <p:grpSpPr>
          <a:xfrm>
            <a:off x="8136720" y="3861625"/>
            <a:ext cx="2589011" cy="2520000"/>
            <a:chOff x="9533980" y="3992430"/>
            <a:chExt cx="2589011" cy="25200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773C49DD-7D0C-4735-821E-81C56727B86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02991" y="3992430"/>
              <a:ext cx="2520000" cy="2520000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1D4E4C2-62E4-430B-A6F8-50A51CE21927}"/>
                </a:ext>
              </a:extLst>
            </p:cNvPr>
            <p:cNvSpPr txBox="1"/>
            <p:nvPr/>
          </p:nvSpPr>
          <p:spPr>
            <a:xfrm>
              <a:off x="10288955" y="5121625"/>
              <a:ext cx="12266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hromosome 15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241B1EA3-C116-4B0A-8ACF-DDCB052DA240}"/>
                </a:ext>
              </a:extLst>
            </p:cNvPr>
            <p:cNvSpPr txBox="1"/>
            <p:nvPr/>
          </p:nvSpPr>
          <p:spPr>
            <a:xfrm>
              <a:off x="9533980" y="4242461"/>
              <a:ext cx="3802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cs typeface="Arial" panose="020B0604020202020204" pitchFamily="34" charset="0"/>
                </a:rPr>
                <a:t>(f)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6E949A41-4097-423B-B1D5-CF9A1B3FD66C}"/>
              </a:ext>
            </a:extLst>
          </p:cNvPr>
          <p:cNvGrpSpPr/>
          <p:nvPr/>
        </p:nvGrpSpPr>
        <p:grpSpPr>
          <a:xfrm>
            <a:off x="815937" y="1150889"/>
            <a:ext cx="2537917" cy="2520000"/>
            <a:chOff x="475667" y="1361417"/>
            <a:chExt cx="2537917" cy="2520000"/>
          </a:xfrm>
        </p:grpSpPr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289BDF74-3583-4897-84A5-F6D070DEC85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3584" y="1361417"/>
              <a:ext cx="2520000" cy="2520000"/>
            </a:xfrm>
            <a:prstGeom prst="rect">
              <a:avLst/>
            </a:prstGeom>
          </p:spPr>
        </p:pic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0A90BE8F-3F38-426E-B488-53B54C3BE832}"/>
                </a:ext>
              </a:extLst>
            </p:cNvPr>
            <p:cNvSpPr txBox="1"/>
            <p:nvPr/>
          </p:nvSpPr>
          <p:spPr>
            <a:xfrm>
              <a:off x="1179548" y="2489599"/>
              <a:ext cx="11480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hromosome 1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B7FD202F-3F67-47FC-9598-06D6BF64E44A}"/>
                </a:ext>
              </a:extLst>
            </p:cNvPr>
            <p:cNvSpPr txBox="1"/>
            <p:nvPr/>
          </p:nvSpPr>
          <p:spPr>
            <a:xfrm>
              <a:off x="475667" y="1552766"/>
              <a:ext cx="4363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F8004240-2760-4092-8EAF-3F4540E56002}"/>
              </a:ext>
            </a:extLst>
          </p:cNvPr>
          <p:cNvGrpSpPr/>
          <p:nvPr/>
        </p:nvGrpSpPr>
        <p:grpSpPr>
          <a:xfrm>
            <a:off x="310006" y="147697"/>
            <a:ext cx="1989381" cy="887304"/>
            <a:chOff x="4946650" y="547300"/>
            <a:chExt cx="1989381" cy="887304"/>
          </a:xfrm>
        </p:grpSpPr>
        <p:sp>
          <p:nvSpPr>
            <p:cNvPr id="29" name="矩形: 圆角 28">
              <a:extLst>
                <a:ext uri="{FF2B5EF4-FFF2-40B4-BE49-F238E27FC236}">
                  <a16:creationId xmlns:a16="http://schemas.microsoft.com/office/drawing/2014/main" id="{24A1772A-8632-41ED-A18C-5D9062E1F017}"/>
                </a:ext>
              </a:extLst>
            </p:cNvPr>
            <p:cNvSpPr/>
            <p:nvPr/>
          </p:nvSpPr>
          <p:spPr>
            <a:xfrm>
              <a:off x="4946650" y="596900"/>
              <a:ext cx="293970" cy="158750"/>
            </a:xfrm>
            <a:prstGeom prst="roundRect">
              <a:avLst/>
            </a:prstGeom>
            <a:solidFill>
              <a:srgbClr val="FD7E00"/>
            </a:solidFill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1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249DA30-7F18-42CF-B019-B4B8A500CD55}"/>
                </a:ext>
              </a:extLst>
            </p:cNvPr>
            <p:cNvSpPr txBox="1"/>
            <p:nvPr/>
          </p:nvSpPr>
          <p:spPr>
            <a:xfrm>
              <a:off x="5302250" y="547300"/>
              <a:ext cx="16337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>
                  <a:latin typeface="Arial" panose="020B0604020202020204" pitchFamily="34" charset="0"/>
                  <a:cs typeface="Arial" panose="020B0604020202020204" pitchFamily="34" charset="0"/>
                </a:rPr>
                <a:t>Chromatin </a:t>
              </a:r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interactions 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: 圆角 30">
              <a:extLst>
                <a:ext uri="{FF2B5EF4-FFF2-40B4-BE49-F238E27FC236}">
                  <a16:creationId xmlns:a16="http://schemas.microsoft.com/office/drawing/2014/main" id="{D773A645-5EA7-45C6-92D4-7EDB140741CB}"/>
                </a:ext>
              </a:extLst>
            </p:cNvPr>
            <p:cNvSpPr/>
            <p:nvPr/>
          </p:nvSpPr>
          <p:spPr>
            <a:xfrm>
              <a:off x="4946650" y="1222594"/>
              <a:ext cx="293970" cy="158750"/>
            </a:xfrm>
            <a:prstGeom prst="roundRect">
              <a:avLst/>
            </a:prstGeom>
            <a:solidFill>
              <a:srgbClr val="0000CC"/>
            </a:solidFill>
            <a:ln>
              <a:solidFill>
                <a:srgbClr val="0000CC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381D1DBE-7535-4E4E-A3BD-283D2EE72CF9}"/>
                </a:ext>
              </a:extLst>
            </p:cNvPr>
            <p:cNvSpPr txBox="1"/>
            <p:nvPr/>
          </p:nvSpPr>
          <p:spPr>
            <a:xfrm>
              <a:off x="5302250" y="1172994"/>
              <a:ext cx="12586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enomic risk loci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: 圆角 32">
              <a:extLst>
                <a:ext uri="{FF2B5EF4-FFF2-40B4-BE49-F238E27FC236}">
                  <a16:creationId xmlns:a16="http://schemas.microsoft.com/office/drawing/2014/main" id="{853AB04B-3E98-454F-A4F0-B077A67DA89E}"/>
                </a:ext>
              </a:extLst>
            </p:cNvPr>
            <p:cNvSpPr/>
            <p:nvPr/>
          </p:nvSpPr>
          <p:spPr>
            <a:xfrm>
              <a:off x="4946650" y="907831"/>
              <a:ext cx="293970" cy="158750"/>
            </a:xfrm>
            <a:prstGeom prst="roundRect">
              <a:avLst/>
            </a:prstGeom>
            <a:solidFill>
              <a:srgbClr val="99D49B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629D881E-AB39-4164-93DB-DDB59DFB0DA8}"/>
                </a:ext>
              </a:extLst>
            </p:cNvPr>
            <p:cNvSpPr txBox="1"/>
            <p:nvPr/>
          </p:nvSpPr>
          <p:spPr>
            <a:xfrm>
              <a:off x="5302250" y="858231"/>
              <a:ext cx="6078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QTLs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76063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36</Words>
  <Application>Microsoft Office PowerPoint</Application>
  <PresentationFormat>宽屏</PresentationFormat>
  <Paragraphs>1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wen TAO (20617230)</dc:creator>
  <cp:lastModifiedBy>Yiwen TAO (20617230)</cp:lastModifiedBy>
  <cp:revision>3</cp:revision>
  <dcterms:created xsi:type="dcterms:W3CDTF">2025-01-22T04:53:28Z</dcterms:created>
  <dcterms:modified xsi:type="dcterms:W3CDTF">2025-01-22T05:21:39Z</dcterms:modified>
</cp:coreProperties>
</file>